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5"/>
  </p:notesMasterIdLst>
  <p:sldIdLst>
    <p:sldId id="271" r:id="rId2"/>
    <p:sldId id="276" r:id="rId3"/>
    <p:sldId id="274" r:id="rId4"/>
  </p:sldIdLst>
  <p:sldSz cx="23774400" cy="2743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640" userDrawn="1">
          <p15:clr>
            <a:srgbClr val="A4A3A4"/>
          </p15:clr>
        </p15:guide>
        <p15:guide id="2" pos="748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ynak, Ahmet (kaynakat)" initials="KA(" lastIdx="9" clrIdx="0">
    <p:extLst>
      <p:ext uri="{19B8F6BF-5375-455C-9EA6-DF929625EA0E}">
        <p15:presenceInfo xmlns:p15="http://schemas.microsoft.com/office/powerpoint/2012/main" userId="S::kaynakat@mail.uc.edu::e30822f5-f881-493f-bf88-3d523b0e27a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52E05A4-9977-4D41-A56D-603C3535D7B2}" v="9" dt="2025-03-10T14:08:56.09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641" autoAdjust="0"/>
    <p:restoredTop sz="91081" autoAdjust="0"/>
  </p:normalViewPr>
  <p:slideViewPr>
    <p:cSldViewPr snapToGrid="0">
      <p:cViewPr>
        <p:scale>
          <a:sx n="66" d="100"/>
          <a:sy n="66" d="100"/>
        </p:scale>
        <p:origin x="1400" y="32"/>
      </p:cViewPr>
      <p:guideLst>
        <p:guide orient="horz" pos="8640"/>
        <p:guide pos="74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microsoft.com/office/2016/11/relationships/changesInfo" Target="changesInfos/changesInfo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ynak, Ahmet (kaynakat)" userId="e30822f5-f881-493f-bf88-3d523b0e27a6" providerId="ADAL" clId="{A52E05A4-9977-4D41-A56D-603C3535D7B2}"/>
    <pc:docChg chg="delSld modSld">
      <pc:chgData name="Kaynak, Ahmet (kaynakat)" userId="e30822f5-f881-493f-bf88-3d523b0e27a6" providerId="ADAL" clId="{A52E05A4-9977-4D41-A56D-603C3535D7B2}" dt="2025-03-10T14:13:42.371" v="157" actId="47"/>
      <pc:docMkLst>
        <pc:docMk/>
      </pc:docMkLst>
      <pc:sldChg chg="delSp modSp del mod modNotesTx">
        <pc:chgData name="Kaynak, Ahmet (kaynakat)" userId="e30822f5-f881-493f-bf88-3d523b0e27a6" providerId="ADAL" clId="{A52E05A4-9977-4D41-A56D-603C3535D7B2}" dt="2025-03-10T14:13:42.371" v="157" actId="47"/>
        <pc:sldMkLst>
          <pc:docMk/>
          <pc:sldMk cId="626253995" sldId="275"/>
        </pc:sldMkLst>
        <pc:spChg chg="mod">
          <ac:chgData name="Kaynak, Ahmet (kaynakat)" userId="e30822f5-f881-493f-bf88-3d523b0e27a6" providerId="ADAL" clId="{A52E05A4-9977-4D41-A56D-603C3535D7B2}" dt="2025-03-10T14:09:37.024" v="154" actId="1037"/>
          <ac:spMkLst>
            <pc:docMk/>
            <pc:sldMk cId="626253995" sldId="275"/>
            <ac:spMk id="6" creationId="{E7B4DA02-D5EF-574C-1E4B-9E14CE4F376A}"/>
          </ac:spMkLst>
        </pc:spChg>
        <pc:spChg chg="mod">
          <ac:chgData name="Kaynak, Ahmet (kaynakat)" userId="e30822f5-f881-493f-bf88-3d523b0e27a6" providerId="ADAL" clId="{A52E05A4-9977-4D41-A56D-603C3535D7B2}" dt="2025-03-10T14:09:21.570" v="73" actId="1036"/>
          <ac:spMkLst>
            <pc:docMk/>
            <pc:sldMk cId="626253995" sldId="275"/>
            <ac:spMk id="7" creationId="{52C9B097-C761-037C-5F61-3F32FDD405F8}"/>
          </ac:spMkLst>
        </pc:spChg>
        <pc:spChg chg="mod">
          <ac:chgData name="Kaynak, Ahmet (kaynakat)" userId="e30822f5-f881-493f-bf88-3d523b0e27a6" providerId="ADAL" clId="{A52E05A4-9977-4D41-A56D-603C3535D7B2}" dt="2025-03-10T14:09:21.570" v="73" actId="1036"/>
          <ac:spMkLst>
            <pc:docMk/>
            <pc:sldMk cId="626253995" sldId="275"/>
            <ac:spMk id="8" creationId="{3A16F7B4-40CB-BC71-7AA9-0749BEA30468}"/>
          </ac:spMkLst>
        </pc:spChg>
        <pc:spChg chg="del mod">
          <ac:chgData name="Kaynak, Ahmet (kaynakat)" userId="e30822f5-f881-493f-bf88-3d523b0e27a6" providerId="ADAL" clId="{A52E05A4-9977-4D41-A56D-603C3535D7B2}" dt="2025-03-10T14:06:40.335" v="6"/>
          <ac:spMkLst>
            <pc:docMk/>
            <pc:sldMk cId="626253995" sldId="275"/>
            <ac:spMk id="20" creationId="{BD96C91A-8EFD-BC16-2330-CAC41F047D42}"/>
          </ac:spMkLst>
        </pc:spChg>
        <pc:spChg chg="mod">
          <ac:chgData name="Kaynak, Ahmet (kaynakat)" userId="e30822f5-f881-493f-bf88-3d523b0e27a6" providerId="ADAL" clId="{A52E05A4-9977-4D41-A56D-603C3535D7B2}" dt="2025-03-10T14:09:30.141" v="103" actId="1037"/>
          <ac:spMkLst>
            <pc:docMk/>
            <pc:sldMk cId="626253995" sldId="275"/>
            <ac:spMk id="116" creationId="{2ECC738A-9B05-5531-EEB8-A6310D577991}"/>
          </ac:spMkLst>
        </pc:spChg>
        <pc:grpChg chg="mod">
          <ac:chgData name="Kaynak, Ahmet (kaynakat)" userId="e30822f5-f881-493f-bf88-3d523b0e27a6" providerId="ADAL" clId="{A52E05A4-9977-4D41-A56D-603C3535D7B2}" dt="2025-03-10T14:09:55.261" v="156" actId="1076"/>
          <ac:grpSpMkLst>
            <pc:docMk/>
            <pc:sldMk cId="626253995" sldId="275"/>
            <ac:grpSpMk id="2" creationId="{0D95F83D-4314-4C05-1FFC-803796C0B0C0}"/>
          </ac:grpSpMkLst>
        </pc:grpChg>
        <pc:graphicFrameChg chg="mod">
          <ac:chgData name="Kaynak, Ahmet (kaynakat)" userId="e30822f5-f881-493f-bf88-3d523b0e27a6" providerId="ADAL" clId="{A52E05A4-9977-4D41-A56D-603C3535D7B2}" dt="2025-03-10T14:07:27.330" v="10" actId="1076"/>
          <ac:graphicFrameMkLst>
            <pc:docMk/>
            <pc:sldMk cId="626253995" sldId="275"/>
            <ac:graphicFrameMk id="3" creationId="{8C97FAC2-E267-A11C-8B33-28C7C9DF1A75}"/>
          </ac:graphicFrameMkLst>
        </pc:graphicFrameChg>
        <pc:graphicFrameChg chg="mod">
          <ac:chgData name="Kaynak, Ahmet (kaynakat)" userId="e30822f5-f881-493f-bf88-3d523b0e27a6" providerId="ADAL" clId="{A52E05A4-9977-4D41-A56D-603C3535D7B2}" dt="2025-03-10T14:09:05.426" v="47" actId="554"/>
          <ac:graphicFrameMkLst>
            <pc:docMk/>
            <pc:sldMk cId="626253995" sldId="275"/>
            <ac:graphicFrameMk id="62" creationId="{DB0EDD14-725B-A570-F7DE-E432E899E4BD}"/>
          </ac:graphicFrameMkLst>
        </pc:graphicFrameChg>
        <pc:graphicFrameChg chg="mod">
          <ac:chgData name="Kaynak, Ahmet (kaynakat)" userId="e30822f5-f881-493f-bf88-3d523b0e27a6" providerId="ADAL" clId="{A52E05A4-9977-4D41-A56D-603C3535D7B2}" dt="2025-03-10T14:09:05.426" v="47" actId="554"/>
          <ac:graphicFrameMkLst>
            <pc:docMk/>
            <pc:sldMk cId="626253995" sldId="275"/>
            <ac:graphicFrameMk id="63" creationId="{07EE6657-F0CC-05A3-2A5E-13E66FB4CD84}"/>
          </ac:graphicFrameMkLst>
        </pc:graphicFrameChg>
        <pc:graphicFrameChg chg="mod">
          <ac:chgData name="Kaynak, Ahmet (kaynakat)" userId="e30822f5-f881-493f-bf88-3d523b0e27a6" providerId="ADAL" clId="{A52E05A4-9977-4D41-A56D-603C3535D7B2}" dt="2025-03-10T14:09:05.426" v="47" actId="554"/>
          <ac:graphicFrameMkLst>
            <pc:docMk/>
            <pc:sldMk cId="626253995" sldId="275"/>
            <ac:graphicFrameMk id="64" creationId="{7CC5D38C-BD5C-5DDD-9C6D-55840F692064}"/>
          </ac:graphicFrameMkLst>
        </pc:graphicFrameChg>
        <pc:graphicFrameChg chg="mod">
          <ac:chgData name="Kaynak, Ahmet (kaynakat)" userId="e30822f5-f881-493f-bf88-3d523b0e27a6" providerId="ADAL" clId="{A52E05A4-9977-4D41-A56D-603C3535D7B2}" dt="2025-03-10T14:09:05.426" v="47" actId="554"/>
          <ac:graphicFrameMkLst>
            <pc:docMk/>
            <pc:sldMk cId="626253995" sldId="275"/>
            <ac:graphicFrameMk id="65" creationId="{DFE0B74B-BA52-14BA-A154-EE9D38AE62E3}"/>
          </ac:graphicFrameMkLst>
        </pc:graphicFrameChg>
      </pc:sldChg>
    </pc:docChg>
  </pc:docChgLst>
  <pc:docChgLst>
    <pc:chgData name="Kaynak, Ahmet (kaynakat)" userId="e30822f5-f881-493f-bf88-3d523b0e27a6" providerId="ADAL" clId="{DAE10789-223E-4F05-831A-0DC0A804EB95}"/>
    <pc:docChg chg="undo custSel addSld modSld">
      <pc:chgData name="Kaynak, Ahmet (kaynakat)" userId="e30822f5-f881-493f-bf88-3d523b0e27a6" providerId="ADAL" clId="{DAE10789-223E-4F05-831A-0DC0A804EB95}" dt="2025-01-22T23:22:36.829" v="203" actId="1076"/>
      <pc:docMkLst>
        <pc:docMk/>
      </pc:docMkLst>
      <pc:sldChg chg="addSp modSp mod">
        <pc:chgData name="Kaynak, Ahmet (kaynakat)" userId="e30822f5-f881-493f-bf88-3d523b0e27a6" providerId="ADAL" clId="{DAE10789-223E-4F05-831A-0DC0A804EB95}" dt="2025-01-22T23:22:05.777" v="197" actId="1076"/>
        <pc:sldMkLst>
          <pc:docMk/>
          <pc:sldMk cId="3464901101" sldId="271"/>
        </pc:sldMkLst>
        <pc:spChg chg="add mod">
          <ac:chgData name="Kaynak, Ahmet (kaynakat)" userId="e30822f5-f881-493f-bf88-3d523b0e27a6" providerId="ADAL" clId="{DAE10789-223E-4F05-831A-0DC0A804EB95}" dt="2025-01-22T23:22:05.777" v="197" actId="1076"/>
          <ac:spMkLst>
            <pc:docMk/>
            <pc:sldMk cId="3464901101" sldId="271"/>
            <ac:spMk id="2" creationId="{ADDB5457-0FCE-6C09-0DBC-BB5F66861AED}"/>
          </ac:spMkLst>
        </pc:spChg>
        <pc:graphicFrameChg chg="mod">
          <ac:chgData name="Kaynak, Ahmet (kaynakat)" userId="e30822f5-f881-493f-bf88-3d523b0e27a6" providerId="ADAL" clId="{DAE10789-223E-4F05-831A-0DC0A804EB95}" dt="2025-01-22T23:21:57.656" v="195" actId="1076"/>
          <ac:graphicFrameMkLst>
            <pc:docMk/>
            <pc:sldMk cId="3464901101" sldId="271"/>
            <ac:graphicFrameMk id="11" creationId="{4768C970-AE78-2323-C6B9-760337C9E7AC}"/>
          </ac:graphicFrameMkLst>
        </pc:graphicFrameChg>
        <pc:graphicFrameChg chg="mod">
          <ac:chgData name="Kaynak, Ahmet (kaynakat)" userId="e30822f5-f881-493f-bf88-3d523b0e27a6" providerId="ADAL" clId="{DAE10789-223E-4F05-831A-0DC0A804EB95}" dt="2025-01-22T23:21:54.248" v="194" actId="1076"/>
          <ac:graphicFrameMkLst>
            <pc:docMk/>
            <pc:sldMk cId="3464901101" sldId="271"/>
            <ac:graphicFrameMk id="12" creationId="{2A7A4D7E-D612-0418-6A2D-5505C0CF257A}"/>
          </ac:graphicFrameMkLst>
        </pc:graphicFrameChg>
        <pc:graphicFrameChg chg="mod">
          <ac:chgData name="Kaynak, Ahmet (kaynakat)" userId="e30822f5-f881-493f-bf88-3d523b0e27a6" providerId="ADAL" clId="{DAE10789-223E-4F05-831A-0DC0A804EB95}" dt="2025-01-22T23:21:51.799" v="193" actId="1076"/>
          <ac:graphicFrameMkLst>
            <pc:docMk/>
            <pc:sldMk cId="3464901101" sldId="271"/>
            <ac:graphicFrameMk id="13" creationId="{AA823692-FD2C-57E8-0EC5-2490C6B4814D}"/>
          </ac:graphicFrameMkLst>
        </pc:graphicFrameChg>
      </pc:sldChg>
      <pc:sldChg chg="addSp delSp modSp mod">
        <pc:chgData name="Kaynak, Ahmet (kaynakat)" userId="e30822f5-f881-493f-bf88-3d523b0e27a6" providerId="ADAL" clId="{DAE10789-223E-4F05-831A-0DC0A804EB95}" dt="2025-01-22T23:22:25.541" v="201" actId="1076"/>
        <pc:sldMkLst>
          <pc:docMk/>
          <pc:sldMk cId="3456804316" sldId="274"/>
        </pc:sldMkLst>
        <pc:spChg chg="add mod">
          <ac:chgData name="Kaynak, Ahmet (kaynakat)" userId="e30822f5-f881-493f-bf88-3d523b0e27a6" providerId="ADAL" clId="{DAE10789-223E-4F05-831A-0DC0A804EB95}" dt="2025-01-14T19:28:49.965" v="155" actId="1076"/>
          <ac:spMkLst>
            <pc:docMk/>
            <pc:sldMk cId="3456804316" sldId="274"/>
            <ac:spMk id="3" creationId="{532FCBF3-9CCD-4405-C36C-EAA37B859B21}"/>
          </ac:spMkLst>
        </pc:spChg>
        <pc:spChg chg="add mod">
          <ac:chgData name="Kaynak, Ahmet (kaynakat)" userId="e30822f5-f881-493f-bf88-3d523b0e27a6" providerId="ADAL" clId="{DAE10789-223E-4F05-831A-0DC0A804EB95}" dt="2025-01-14T19:28:49.965" v="155" actId="1076"/>
          <ac:spMkLst>
            <pc:docMk/>
            <pc:sldMk cId="3456804316" sldId="274"/>
            <ac:spMk id="4" creationId="{1E73E3B3-EFC4-8563-FF69-FAB7E5DC7525}"/>
          </ac:spMkLst>
        </pc:spChg>
        <pc:spChg chg="add mod">
          <ac:chgData name="Kaynak, Ahmet (kaynakat)" userId="e30822f5-f881-493f-bf88-3d523b0e27a6" providerId="ADAL" clId="{DAE10789-223E-4F05-831A-0DC0A804EB95}" dt="2025-01-22T23:22:25.541" v="201" actId="1076"/>
          <ac:spMkLst>
            <pc:docMk/>
            <pc:sldMk cId="3456804316" sldId="274"/>
            <ac:spMk id="5" creationId="{E13D63C6-30EC-47A7-C88A-7E5C8ECFD044}"/>
          </ac:spMkLst>
        </pc:spChg>
        <pc:spChg chg="mod">
          <ac:chgData name="Kaynak, Ahmet (kaynakat)" userId="e30822f5-f881-493f-bf88-3d523b0e27a6" providerId="ADAL" clId="{DAE10789-223E-4F05-831A-0DC0A804EB95}" dt="2025-01-14T19:28:49.965" v="155" actId="1076"/>
          <ac:spMkLst>
            <pc:docMk/>
            <pc:sldMk cId="3456804316" sldId="274"/>
            <ac:spMk id="78" creationId="{CB68D036-513F-4D8A-8508-F3024C4DE704}"/>
          </ac:spMkLst>
        </pc:spChg>
        <pc:spChg chg="mod">
          <ac:chgData name="Kaynak, Ahmet (kaynakat)" userId="e30822f5-f881-493f-bf88-3d523b0e27a6" providerId="ADAL" clId="{DAE10789-223E-4F05-831A-0DC0A804EB95}" dt="2025-01-14T19:28:49.965" v="155" actId="1076"/>
          <ac:spMkLst>
            <pc:docMk/>
            <pc:sldMk cId="3456804316" sldId="274"/>
            <ac:spMk id="230" creationId="{92374B65-8545-4F24-9EFB-52F162DD0265}"/>
          </ac:spMkLst>
        </pc:spChg>
        <pc:spChg chg="mod">
          <ac:chgData name="Kaynak, Ahmet (kaynakat)" userId="e30822f5-f881-493f-bf88-3d523b0e27a6" providerId="ADAL" clId="{DAE10789-223E-4F05-831A-0DC0A804EB95}" dt="2025-01-14T19:28:49.965" v="155" actId="1076"/>
          <ac:spMkLst>
            <pc:docMk/>
            <pc:sldMk cId="3456804316" sldId="274"/>
            <ac:spMk id="231" creationId="{2114D12A-DA04-48C4-94AE-BF7E3E0D9AC9}"/>
          </ac:spMkLst>
        </pc:spChg>
        <pc:spChg chg="mod">
          <ac:chgData name="Kaynak, Ahmet (kaynakat)" userId="e30822f5-f881-493f-bf88-3d523b0e27a6" providerId="ADAL" clId="{DAE10789-223E-4F05-831A-0DC0A804EB95}" dt="2025-01-14T19:28:49.965" v="155" actId="1076"/>
          <ac:spMkLst>
            <pc:docMk/>
            <pc:sldMk cId="3456804316" sldId="274"/>
            <ac:spMk id="238" creationId="{F3E60488-128D-4BF0-B614-5A54FF9BC16D}"/>
          </ac:spMkLst>
        </pc:spChg>
        <pc:picChg chg="mod">
          <ac:chgData name="Kaynak, Ahmet (kaynakat)" userId="e30822f5-f881-493f-bf88-3d523b0e27a6" providerId="ADAL" clId="{DAE10789-223E-4F05-831A-0DC0A804EB95}" dt="2025-01-14T19:28:49.965" v="155" actId="1076"/>
          <ac:picMkLst>
            <pc:docMk/>
            <pc:sldMk cId="3456804316" sldId="274"/>
            <ac:picMk id="2" creationId="{D896F95C-AA02-190C-9D6D-6DDA7613D0A9}"/>
          </ac:picMkLst>
        </pc:picChg>
        <pc:picChg chg="mod ord">
          <ac:chgData name="Kaynak, Ahmet (kaynakat)" userId="e30822f5-f881-493f-bf88-3d523b0e27a6" providerId="ADAL" clId="{DAE10789-223E-4F05-831A-0DC0A804EB95}" dt="2025-01-14T19:28:49.965" v="155" actId="1076"/>
          <ac:picMkLst>
            <pc:docMk/>
            <pc:sldMk cId="3456804316" sldId="274"/>
            <ac:picMk id="6" creationId="{8BF73A2F-83D7-E747-C3B3-41CFB4843868}"/>
          </ac:picMkLst>
        </pc:picChg>
        <pc:picChg chg="mod">
          <ac:chgData name="Kaynak, Ahmet (kaynakat)" userId="e30822f5-f881-493f-bf88-3d523b0e27a6" providerId="ADAL" clId="{DAE10789-223E-4F05-831A-0DC0A804EB95}" dt="2025-01-14T19:28:49.965" v="155" actId="1076"/>
          <ac:picMkLst>
            <pc:docMk/>
            <pc:sldMk cId="3456804316" sldId="274"/>
            <ac:picMk id="10" creationId="{780D7E00-6B62-755B-2087-72D3DE711E36}"/>
          </ac:picMkLst>
        </pc:picChg>
        <pc:picChg chg="mod">
          <ac:chgData name="Kaynak, Ahmet (kaynakat)" userId="e30822f5-f881-493f-bf88-3d523b0e27a6" providerId="ADAL" clId="{DAE10789-223E-4F05-831A-0DC0A804EB95}" dt="2025-01-14T18:51:42.860" v="50" actId="1076"/>
          <ac:picMkLst>
            <pc:docMk/>
            <pc:sldMk cId="3456804316" sldId="274"/>
            <ac:picMk id="11" creationId="{46E6EFFD-F2E7-161E-8D27-BBA2CDB41685}"/>
          </ac:picMkLst>
        </pc:picChg>
        <pc:picChg chg="mod">
          <ac:chgData name="Kaynak, Ahmet (kaynakat)" userId="e30822f5-f881-493f-bf88-3d523b0e27a6" providerId="ADAL" clId="{DAE10789-223E-4F05-831A-0DC0A804EB95}" dt="2025-01-14T18:54:11.492" v="73" actId="1076"/>
          <ac:picMkLst>
            <pc:docMk/>
            <pc:sldMk cId="3456804316" sldId="274"/>
            <ac:picMk id="12" creationId="{D9F83532-1768-D348-42D1-E8D1B61C8245}"/>
          </ac:picMkLst>
        </pc:picChg>
        <pc:picChg chg="mod">
          <ac:chgData name="Kaynak, Ahmet (kaynakat)" userId="e30822f5-f881-493f-bf88-3d523b0e27a6" providerId="ADAL" clId="{DAE10789-223E-4F05-831A-0DC0A804EB95}" dt="2025-01-14T19:28:49.965" v="155" actId="1076"/>
          <ac:picMkLst>
            <pc:docMk/>
            <pc:sldMk cId="3456804316" sldId="274"/>
            <ac:picMk id="13" creationId="{5C7E18F7-7D50-4310-B712-F2DC2755E4CC}"/>
          </ac:picMkLst>
        </pc:picChg>
      </pc:sldChg>
      <pc:sldChg chg="addSp modSp mod">
        <pc:chgData name="Kaynak, Ahmet (kaynakat)" userId="e30822f5-f881-493f-bf88-3d523b0e27a6" providerId="ADAL" clId="{DAE10789-223E-4F05-831A-0DC0A804EB95}" dt="2025-01-22T23:22:36.829" v="203" actId="1076"/>
        <pc:sldMkLst>
          <pc:docMk/>
          <pc:sldMk cId="626253995" sldId="275"/>
        </pc:sldMkLst>
      </pc:sldChg>
      <pc:sldChg chg="addSp delSp modSp add mod">
        <pc:chgData name="Kaynak, Ahmet (kaynakat)" userId="e30822f5-f881-493f-bf88-3d523b0e27a6" providerId="ADAL" clId="{DAE10789-223E-4F05-831A-0DC0A804EB95}" dt="2025-01-22T23:22:18.938" v="199" actId="1076"/>
        <pc:sldMkLst>
          <pc:docMk/>
          <pc:sldMk cId="4226183725" sldId="276"/>
        </pc:sldMkLst>
        <pc:spChg chg="add mod">
          <ac:chgData name="Kaynak, Ahmet (kaynakat)" userId="e30822f5-f881-493f-bf88-3d523b0e27a6" providerId="ADAL" clId="{DAE10789-223E-4F05-831A-0DC0A804EB95}" dt="2025-01-22T23:22:18.938" v="199" actId="1076"/>
          <ac:spMkLst>
            <pc:docMk/>
            <pc:sldMk cId="4226183725" sldId="276"/>
            <ac:spMk id="2" creationId="{5FC16EC5-ED3A-2702-AA3D-DE7128271171}"/>
          </ac:spMkLst>
        </pc:spChg>
        <pc:spChg chg="mod">
          <ac:chgData name="Kaynak, Ahmet (kaynakat)" userId="e30822f5-f881-493f-bf88-3d523b0e27a6" providerId="ADAL" clId="{DAE10789-223E-4F05-831A-0DC0A804EB95}" dt="2025-01-14T16:20:49.035" v="10"/>
          <ac:spMkLst>
            <pc:docMk/>
            <pc:sldMk cId="4226183725" sldId="276"/>
            <ac:spMk id="29" creationId="{777794E9-B486-41B0-09DC-A43E48CA1DF9}"/>
          </ac:spMkLst>
        </pc:spChg>
        <pc:spChg chg="mod">
          <ac:chgData name="Kaynak, Ahmet (kaynakat)" userId="e30822f5-f881-493f-bf88-3d523b0e27a6" providerId="ADAL" clId="{DAE10789-223E-4F05-831A-0DC0A804EB95}" dt="2025-01-14T16:20:49.035" v="10"/>
          <ac:spMkLst>
            <pc:docMk/>
            <pc:sldMk cId="4226183725" sldId="276"/>
            <ac:spMk id="30" creationId="{B2B26E77-15E2-2AAA-2FFC-242458C02C8B}"/>
          </ac:spMkLst>
        </pc:spChg>
        <pc:spChg chg="mod">
          <ac:chgData name="Kaynak, Ahmet (kaynakat)" userId="e30822f5-f881-493f-bf88-3d523b0e27a6" providerId="ADAL" clId="{DAE10789-223E-4F05-831A-0DC0A804EB95}" dt="2025-01-14T16:20:49.035" v="10"/>
          <ac:spMkLst>
            <pc:docMk/>
            <pc:sldMk cId="4226183725" sldId="276"/>
            <ac:spMk id="35" creationId="{3DE39A87-E1EC-454F-2214-BD133EA9A895}"/>
          </ac:spMkLst>
        </pc:spChg>
        <pc:spChg chg="mod">
          <ac:chgData name="Kaynak, Ahmet (kaynakat)" userId="e30822f5-f881-493f-bf88-3d523b0e27a6" providerId="ADAL" clId="{DAE10789-223E-4F05-831A-0DC0A804EB95}" dt="2025-01-14T16:20:49.035" v="10"/>
          <ac:spMkLst>
            <pc:docMk/>
            <pc:sldMk cId="4226183725" sldId="276"/>
            <ac:spMk id="37" creationId="{F008E4EE-791F-B001-9113-FC0C74CF8332}"/>
          </ac:spMkLst>
        </pc:spChg>
        <pc:spChg chg="mod">
          <ac:chgData name="Kaynak, Ahmet (kaynakat)" userId="e30822f5-f881-493f-bf88-3d523b0e27a6" providerId="ADAL" clId="{DAE10789-223E-4F05-831A-0DC0A804EB95}" dt="2025-01-14T16:20:49.035" v="10"/>
          <ac:spMkLst>
            <pc:docMk/>
            <pc:sldMk cId="4226183725" sldId="276"/>
            <ac:spMk id="39" creationId="{D97932B0-B896-BB6A-F81F-FCB71F4269C2}"/>
          </ac:spMkLst>
        </pc:spChg>
        <pc:spChg chg="mod">
          <ac:chgData name="Kaynak, Ahmet (kaynakat)" userId="e30822f5-f881-493f-bf88-3d523b0e27a6" providerId="ADAL" clId="{DAE10789-223E-4F05-831A-0DC0A804EB95}" dt="2025-01-14T16:20:49.035" v="10"/>
          <ac:spMkLst>
            <pc:docMk/>
            <pc:sldMk cId="4226183725" sldId="276"/>
            <ac:spMk id="44" creationId="{099779EC-0936-6674-A658-3F8755B52BEF}"/>
          </ac:spMkLst>
        </pc:spChg>
        <pc:spChg chg="mod">
          <ac:chgData name="Kaynak, Ahmet (kaynakat)" userId="e30822f5-f881-493f-bf88-3d523b0e27a6" providerId="ADAL" clId="{DAE10789-223E-4F05-831A-0DC0A804EB95}" dt="2025-01-14T16:20:49.035" v="10"/>
          <ac:spMkLst>
            <pc:docMk/>
            <pc:sldMk cId="4226183725" sldId="276"/>
            <ac:spMk id="46" creationId="{449763AE-5B52-F260-D4D8-206F19BBBBDE}"/>
          </ac:spMkLst>
        </pc:spChg>
        <pc:grpChg chg="mod">
          <ac:chgData name="Kaynak, Ahmet (kaynakat)" userId="e30822f5-f881-493f-bf88-3d523b0e27a6" providerId="ADAL" clId="{DAE10789-223E-4F05-831A-0DC0A804EB95}" dt="2025-01-22T17:03:48.685" v="192" actId="1076"/>
          <ac:grpSpMkLst>
            <pc:docMk/>
            <pc:sldMk cId="4226183725" sldId="276"/>
            <ac:grpSpMk id="21" creationId="{7FED581C-7C68-7721-8263-B41F278A3673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AD8B76-510C-5840-AFF8-56732EE74642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92325" y="1143000"/>
            <a:ext cx="26733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0FCF20-DC62-4C47-927D-B0873A9B0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6614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83080" y="4489452"/>
            <a:ext cx="20208240" cy="9550400"/>
          </a:xfrm>
        </p:spPr>
        <p:txBody>
          <a:bodyPr anchor="b"/>
          <a:lstStyle>
            <a:lvl1pPr algn="ctr">
              <a:defRPr sz="1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971800" y="14408152"/>
            <a:ext cx="17830800" cy="6623048"/>
          </a:xfrm>
        </p:spPr>
        <p:txBody>
          <a:bodyPr/>
          <a:lstStyle>
            <a:lvl1pPr marL="0" indent="0" algn="ctr">
              <a:buNone/>
              <a:defRPr sz="6240"/>
            </a:lvl1pPr>
            <a:lvl2pPr marL="1188720" indent="0" algn="ctr">
              <a:buNone/>
              <a:defRPr sz="5200"/>
            </a:lvl2pPr>
            <a:lvl3pPr marL="2377440" indent="0" algn="ctr">
              <a:buNone/>
              <a:defRPr sz="4680"/>
            </a:lvl3pPr>
            <a:lvl4pPr marL="3566160" indent="0" algn="ctr">
              <a:buNone/>
              <a:defRPr sz="4160"/>
            </a:lvl4pPr>
            <a:lvl5pPr marL="4754880" indent="0" algn="ctr">
              <a:buNone/>
              <a:defRPr sz="4160"/>
            </a:lvl5pPr>
            <a:lvl6pPr marL="5943600" indent="0" algn="ctr">
              <a:buNone/>
              <a:defRPr sz="4160"/>
            </a:lvl6pPr>
            <a:lvl7pPr marL="7132320" indent="0" algn="ctr">
              <a:buNone/>
              <a:defRPr sz="4160"/>
            </a:lvl7pPr>
            <a:lvl8pPr marL="8321040" indent="0" algn="ctr">
              <a:buNone/>
              <a:defRPr sz="4160"/>
            </a:lvl8pPr>
            <a:lvl9pPr marL="9509760" indent="0" algn="ctr">
              <a:buNone/>
              <a:defRPr sz="41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695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469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7013556" y="1460500"/>
            <a:ext cx="5126355" cy="2324735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34491" y="1460500"/>
            <a:ext cx="15081885" cy="2324735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012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92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2109" y="6838958"/>
            <a:ext cx="20505420" cy="11410948"/>
          </a:xfrm>
        </p:spPr>
        <p:txBody>
          <a:bodyPr anchor="b"/>
          <a:lstStyle>
            <a:lvl1pPr>
              <a:defRPr sz="1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22109" y="18357858"/>
            <a:ext cx="20505420" cy="6000748"/>
          </a:xfrm>
        </p:spPr>
        <p:txBody>
          <a:bodyPr/>
          <a:lstStyle>
            <a:lvl1pPr marL="0" indent="0">
              <a:buNone/>
              <a:defRPr sz="6240">
                <a:solidFill>
                  <a:schemeClr val="tx1"/>
                </a:solidFill>
              </a:defRPr>
            </a:lvl1pPr>
            <a:lvl2pPr marL="1188720" indent="0">
              <a:buNone/>
              <a:defRPr sz="5200">
                <a:solidFill>
                  <a:schemeClr val="tx1">
                    <a:tint val="75000"/>
                  </a:schemeClr>
                </a:solidFill>
              </a:defRPr>
            </a:lvl2pPr>
            <a:lvl3pPr marL="2377440" indent="0">
              <a:buNone/>
              <a:defRPr sz="4680">
                <a:solidFill>
                  <a:schemeClr val="tx1">
                    <a:tint val="75000"/>
                  </a:schemeClr>
                </a:solidFill>
              </a:defRPr>
            </a:lvl3pPr>
            <a:lvl4pPr marL="356616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4pPr>
            <a:lvl5pPr marL="475488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5pPr>
            <a:lvl6pPr marL="594360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6pPr>
            <a:lvl7pPr marL="713232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7pPr>
            <a:lvl8pPr marL="832104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8pPr>
            <a:lvl9pPr marL="950976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312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34490" y="7302500"/>
            <a:ext cx="10104120" cy="17405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035790" y="7302500"/>
            <a:ext cx="10104120" cy="17405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252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460506"/>
            <a:ext cx="20505420" cy="53022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7589" y="6724652"/>
            <a:ext cx="10057684" cy="3295648"/>
          </a:xfrm>
        </p:spPr>
        <p:txBody>
          <a:bodyPr anchor="b"/>
          <a:lstStyle>
            <a:lvl1pPr marL="0" indent="0">
              <a:buNone/>
              <a:defRPr sz="6240" b="1"/>
            </a:lvl1pPr>
            <a:lvl2pPr marL="1188720" indent="0">
              <a:buNone/>
              <a:defRPr sz="5200" b="1"/>
            </a:lvl2pPr>
            <a:lvl3pPr marL="2377440" indent="0">
              <a:buNone/>
              <a:defRPr sz="4680" b="1"/>
            </a:lvl3pPr>
            <a:lvl4pPr marL="3566160" indent="0">
              <a:buNone/>
              <a:defRPr sz="4160" b="1"/>
            </a:lvl4pPr>
            <a:lvl5pPr marL="4754880" indent="0">
              <a:buNone/>
              <a:defRPr sz="4160" b="1"/>
            </a:lvl5pPr>
            <a:lvl6pPr marL="5943600" indent="0">
              <a:buNone/>
              <a:defRPr sz="4160" b="1"/>
            </a:lvl6pPr>
            <a:lvl7pPr marL="7132320" indent="0">
              <a:buNone/>
              <a:defRPr sz="4160" b="1"/>
            </a:lvl7pPr>
            <a:lvl8pPr marL="8321040" indent="0">
              <a:buNone/>
              <a:defRPr sz="4160" b="1"/>
            </a:lvl8pPr>
            <a:lvl9pPr marL="9509760" indent="0">
              <a:buNone/>
              <a:defRPr sz="41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37589" y="10020300"/>
            <a:ext cx="10057684" cy="14738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035791" y="6724652"/>
            <a:ext cx="10107217" cy="3295648"/>
          </a:xfrm>
        </p:spPr>
        <p:txBody>
          <a:bodyPr anchor="b"/>
          <a:lstStyle>
            <a:lvl1pPr marL="0" indent="0">
              <a:buNone/>
              <a:defRPr sz="6240" b="1"/>
            </a:lvl1pPr>
            <a:lvl2pPr marL="1188720" indent="0">
              <a:buNone/>
              <a:defRPr sz="5200" b="1"/>
            </a:lvl2pPr>
            <a:lvl3pPr marL="2377440" indent="0">
              <a:buNone/>
              <a:defRPr sz="4680" b="1"/>
            </a:lvl3pPr>
            <a:lvl4pPr marL="3566160" indent="0">
              <a:buNone/>
              <a:defRPr sz="4160" b="1"/>
            </a:lvl4pPr>
            <a:lvl5pPr marL="4754880" indent="0">
              <a:buNone/>
              <a:defRPr sz="4160" b="1"/>
            </a:lvl5pPr>
            <a:lvl6pPr marL="5943600" indent="0">
              <a:buNone/>
              <a:defRPr sz="4160" b="1"/>
            </a:lvl6pPr>
            <a:lvl7pPr marL="7132320" indent="0">
              <a:buNone/>
              <a:defRPr sz="4160" b="1"/>
            </a:lvl7pPr>
            <a:lvl8pPr marL="8321040" indent="0">
              <a:buNone/>
              <a:defRPr sz="4160" b="1"/>
            </a:lvl8pPr>
            <a:lvl9pPr marL="9509760" indent="0">
              <a:buNone/>
              <a:defRPr sz="41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035791" y="10020300"/>
            <a:ext cx="10107217" cy="14738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284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07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699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828800"/>
            <a:ext cx="7667863" cy="6400800"/>
          </a:xfrm>
        </p:spPr>
        <p:txBody>
          <a:bodyPr anchor="b"/>
          <a:lstStyle>
            <a:lvl1pPr>
              <a:defRPr sz="83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107217" y="3949706"/>
            <a:ext cx="12035790" cy="19494500"/>
          </a:xfrm>
        </p:spPr>
        <p:txBody>
          <a:bodyPr/>
          <a:lstStyle>
            <a:lvl1pPr>
              <a:defRPr sz="8320"/>
            </a:lvl1pPr>
            <a:lvl2pPr>
              <a:defRPr sz="7280"/>
            </a:lvl2pPr>
            <a:lvl3pPr>
              <a:defRPr sz="6240"/>
            </a:lvl3pPr>
            <a:lvl4pPr>
              <a:defRPr sz="5200"/>
            </a:lvl4pPr>
            <a:lvl5pPr>
              <a:defRPr sz="5200"/>
            </a:lvl5pPr>
            <a:lvl6pPr>
              <a:defRPr sz="5200"/>
            </a:lvl6pPr>
            <a:lvl7pPr>
              <a:defRPr sz="5200"/>
            </a:lvl7pPr>
            <a:lvl8pPr>
              <a:defRPr sz="5200"/>
            </a:lvl8pPr>
            <a:lvl9pPr>
              <a:defRPr sz="5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7587" y="8229600"/>
            <a:ext cx="7667863" cy="15246352"/>
          </a:xfrm>
        </p:spPr>
        <p:txBody>
          <a:bodyPr/>
          <a:lstStyle>
            <a:lvl1pPr marL="0" indent="0">
              <a:buNone/>
              <a:defRPr sz="4160"/>
            </a:lvl1pPr>
            <a:lvl2pPr marL="1188720" indent="0">
              <a:buNone/>
              <a:defRPr sz="3640"/>
            </a:lvl2pPr>
            <a:lvl3pPr marL="2377440" indent="0">
              <a:buNone/>
              <a:defRPr sz="3120"/>
            </a:lvl3pPr>
            <a:lvl4pPr marL="3566160" indent="0">
              <a:buNone/>
              <a:defRPr sz="2600"/>
            </a:lvl4pPr>
            <a:lvl5pPr marL="4754880" indent="0">
              <a:buNone/>
              <a:defRPr sz="2600"/>
            </a:lvl5pPr>
            <a:lvl6pPr marL="5943600" indent="0">
              <a:buNone/>
              <a:defRPr sz="2600"/>
            </a:lvl6pPr>
            <a:lvl7pPr marL="7132320" indent="0">
              <a:buNone/>
              <a:defRPr sz="2600"/>
            </a:lvl7pPr>
            <a:lvl8pPr marL="8321040" indent="0">
              <a:buNone/>
              <a:defRPr sz="2600"/>
            </a:lvl8pPr>
            <a:lvl9pPr marL="9509760" indent="0">
              <a:buNone/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171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828800"/>
            <a:ext cx="7667863" cy="6400800"/>
          </a:xfrm>
        </p:spPr>
        <p:txBody>
          <a:bodyPr anchor="b"/>
          <a:lstStyle>
            <a:lvl1pPr>
              <a:defRPr sz="83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107217" y="3949706"/>
            <a:ext cx="12035790" cy="19494500"/>
          </a:xfrm>
        </p:spPr>
        <p:txBody>
          <a:bodyPr anchor="t"/>
          <a:lstStyle>
            <a:lvl1pPr marL="0" indent="0">
              <a:buNone/>
              <a:defRPr sz="8320"/>
            </a:lvl1pPr>
            <a:lvl2pPr marL="1188720" indent="0">
              <a:buNone/>
              <a:defRPr sz="7280"/>
            </a:lvl2pPr>
            <a:lvl3pPr marL="2377440" indent="0">
              <a:buNone/>
              <a:defRPr sz="6240"/>
            </a:lvl3pPr>
            <a:lvl4pPr marL="3566160" indent="0">
              <a:buNone/>
              <a:defRPr sz="5200"/>
            </a:lvl4pPr>
            <a:lvl5pPr marL="4754880" indent="0">
              <a:buNone/>
              <a:defRPr sz="5200"/>
            </a:lvl5pPr>
            <a:lvl6pPr marL="5943600" indent="0">
              <a:buNone/>
              <a:defRPr sz="5200"/>
            </a:lvl6pPr>
            <a:lvl7pPr marL="7132320" indent="0">
              <a:buNone/>
              <a:defRPr sz="5200"/>
            </a:lvl7pPr>
            <a:lvl8pPr marL="8321040" indent="0">
              <a:buNone/>
              <a:defRPr sz="5200"/>
            </a:lvl8pPr>
            <a:lvl9pPr marL="9509760" indent="0">
              <a:buNone/>
              <a:defRPr sz="5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7587" y="8229600"/>
            <a:ext cx="7667863" cy="15246352"/>
          </a:xfrm>
        </p:spPr>
        <p:txBody>
          <a:bodyPr/>
          <a:lstStyle>
            <a:lvl1pPr marL="0" indent="0">
              <a:buNone/>
              <a:defRPr sz="4160"/>
            </a:lvl1pPr>
            <a:lvl2pPr marL="1188720" indent="0">
              <a:buNone/>
              <a:defRPr sz="3640"/>
            </a:lvl2pPr>
            <a:lvl3pPr marL="2377440" indent="0">
              <a:buNone/>
              <a:defRPr sz="3120"/>
            </a:lvl3pPr>
            <a:lvl4pPr marL="3566160" indent="0">
              <a:buNone/>
              <a:defRPr sz="2600"/>
            </a:lvl4pPr>
            <a:lvl5pPr marL="4754880" indent="0">
              <a:buNone/>
              <a:defRPr sz="2600"/>
            </a:lvl5pPr>
            <a:lvl6pPr marL="5943600" indent="0">
              <a:buNone/>
              <a:defRPr sz="2600"/>
            </a:lvl6pPr>
            <a:lvl7pPr marL="7132320" indent="0">
              <a:buNone/>
              <a:defRPr sz="2600"/>
            </a:lvl7pPr>
            <a:lvl8pPr marL="8321040" indent="0">
              <a:buNone/>
              <a:defRPr sz="2600"/>
            </a:lvl8pPr>
            <a:lvl9pPr marL="9509760" indent="0">
              <a:buNone/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612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34490" y="1460506"/>
            <a:ext cx="20505420" cy="53022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4490" y="7302500"/>
            <a:ext cx="20505420" cy="174053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34490" y="25425406"/>
            <a:ext cx="534924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D5EB7-1542-4BF7-BA9D-973ECE0FEE59}" type="datetimeFigureOut">
              <a:rPr lang="en-US" smtClean="0"/>
              <a:t>3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875270" y="25425406"/>
            <a:ext cx="802386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90670" y="25425406"/>
            <a:ext cx="534924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9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2377440" rtl="0" eaLnBrk="1" latinLnBrk="0" hangingPunct="1">
        <a:lnSpc>
          <a:spcPct val="90000"/>
        </a:lnSpc>
        <a:spcBef>
          <a:spcPct val="0"/>
        </a:spcBef>
        <a:buNone/>
        <a:defRPr sz="114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94360" indent="-594360" algn="l" defTabSz="2377440" rtl="0" eaLnBrk="1" latinLnBrk="0" hangingPunct="1">
        <a:lnSpc>
          <a:spcPct val="90000"/>
        </a:lnSpc>
        <a:spcBef>
          <a:spcPts val="2600"/>
        </a:spcBef>
        <a:buFont typeface="Arial" panose="020B0604020202020204" pitchFamily="34" charset="0"/>
        <a:buChar char="•"/>
        <a:defRPr sz="7280" kern="1200">
          <a:solidFill>
            <a:schemeClr val="tx1"/>
          </a:solidFill>
          <a:latin typeface="+mn-lt"/>
          <a:ea typeface="+mn-ea"/>
          <a:cs typeface="+mn-cs"/>
        </a:defRPr>
      </a:lvl1pPr>
      <a:lvl2pPr marL="178308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6240" kern="1200">
          <a:solidFill>
            <a:schemeClr val="tx1"/>
          </a:solidFill>
          <a:latin typeface="+mn-lt"/>
          <a:ea typeface="+mn-ea"/>
          <a:cs typeface="+mn-cs"/>
        </a:defRPr>
      </a:lvl2pPr>
      <a:lvl3pPr marL="297180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5200" kern="1200">
          <a:solidFill>
            <a:schemeClr val="tx1"/>
          </a:solidFill>
          <a:latin typeface="+mn-lt"/>
          <a:ea typeface="+mn-ea"/>
          <a:cs typeface="+mn-cs"/>
        </a:defRPr>
      </a:lvl3pPr>
      <a:lvl4pPr marL="416052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4pPr>
      <a:lvl5pPr marL="534924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5pPr>
      <a:lvl6pPr marL="653796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6pPr>
      <a:lvl7pPr marL="772668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7pPr>
      <a:lvl8pPr marL="891540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8pPr>
      <a:lvl9pPr marL="1010412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1pPr>
      <a:lvl2pPr marL="118872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2pPr>
      <a:lvl3pPr marL="237744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3pPr>
      <a:lvl4pPr marL="356616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4pPr>
      <a:lvl5pPr marL="475488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5pPr>
      <a:lvl6pPr marL="594360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6pPr>
      <a:lvl7pPr marL="713232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7pPr>
      <a:lvl8pPr marL="832104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8pPr>
      <a:lvl9pPr marL="950976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768C970-AE78-2323-C6B9-760337C9E7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3710419"/>
              </p:ext>
            </p:extLst>
          </p:nvPr>
        </p:nvGraphicFramePr>
        <p:xfrm>
          <a:off x="8276431" y="16621231"/>
          <a:ext cx="7221538" cy="7854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2735231" imgH="2977754" progId="Prism6.Document">
                  <p:embed/>
                </p:oleObj>
              </mc:Choice>
              <mc:Fallback>
                <p:oleObj name="Prism 6" r:id="rId2" imgW="2735231" imgH="2977754" progId="Prism6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4768C970-AE78-2323-C6B9-760337C9E7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276431" y="16621231"/>
                        <a:ext cx="7221538" cy="7854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2A7A4D7E-D612-0418-6A2D-5505C0CF25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3652623"/>
              </p:ext>
            </p:extLst>
          </p:nvPr>
        </p:nvGraphicFramePr>
        <p:xfrm>
          <a:off x="7764952" y="9216659"/>
          <a:ext cx="7297738" cy="7827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2780968" imgH="2986757" progId="Prism6.Document">
                  <p:embed/>
                </p:oleObj>
              </mc:Choice>
              <mc:Fallback>
                <p:oleObj name="Prism 6" r:id="rId4" imgW="2780968" imgH="2986757" progId="Prism6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2A7A4D7E-D612-0418-6A2D-5505C0CF25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764952" y="9216659"/>
                        <a:ext cx="7297738" cy="7827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AA823692-FD2C-57E8-0EC5-2490C6B481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8818410"/>
              </p:ext>
            </p:extLst>
          </p:nvPr>
        </p:nvGraphicFramePr>
        <p:xfrm>
          <a:off x="7237413" y="1785100"/>
          <a:ext cx="7296150" cy="7827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6" imgW="2780968" imgH="2986757" progId="Prism6.Document">
                  <p:embed/>
                </p:oleObj>
              </mc:Choice>
              <mc:Fallback>
                <p:oleObj name="Prism 6" r:id="rId6" imgW="2780968" imgH="2986757" progId="Prism6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AA823692-FD2C-57E8-0EC5-2490C6B481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237413" y="1785100"/>
                        <a:ext cx="7296150" cy="7827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ADDB5457-0FCE-6C09-0DBC-BB5F66861AED}"/>
              </a:ext>
            </a:extLst>
          </p:cNvPr>
          <p:cNvSpPr txBox="1"/>
          <p:nvPr/>
        </p:nvSpPr>
        <p:spPr>
          <a:xfrm>
            <a:off x="1193373" y="24699121"/>
            <a:ext cx="2098082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lang="en-US" sz="36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Quantification of exposed PS area, HSP70 area, PS and Hsp70 co-localized areas on cancer cells. </a:t>
            </a:r>
            <a:r>
              <a:rPr lang="en-US" sz="36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ar graphs show quantification of area of exposure of surface PS (</a:t>
            </a:r>
            <a:r>
              <a:rPr lang="en-US" sz="36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op panel</a:t>
            </a:r>
            <a:r>
              <a:rPr lang="en-US" sz="36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, surface Hsp70 (</a:t>
            </a:r>
            <a:r>
              <a:rPr lang="en-US" sz="36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iddle panel</a:t>
            </a:r>
            <a:r>
              <a:rPr lang="en-US" sz="36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 and co-localization of PS and Hsp70 (</a:t>
            </a:r>
            <a:r>
              <a:rPr lang="en-US" sz="36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ottom panel</a:t>
            </a:r>
            <a:r>
              <a:rPr lang="en-US" sz="36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) in HPDE, AsPC-1 and MiaPaCa-2 cells. </a:t>
            </a:r>
            <a:endParaRPr 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49011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A7E766E-D3B8-3737-77B5-A748D98DBE4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7FED581C-7C68-7721-8263-B41F278A3673}"/>
              </a:ext>
            </a:extLst>
          </p:cNvPr>
          <p:cNvGrpSpPr/>
          <p:nvPr/>
        </p:nvGrpSpPr>
        <p:grpSpPr>
          <a:xfrm>
            <a:off x="7596646" y="6998075"/>
            <a:ext cx="7165994" cy="6162763"/>
            <a:chOff x="9499787" y="6974218"/>
            <a:chExt cx="4702434" cy="3672338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C1EEFF61-E103-7882-0011-DF36A089C7BB}"/>
                </a:ext>
              </a:extLst>
            </p:cNvPr>
            <p:cNvGrpSpPr/>
            <p:nvPr/>
          </p:nvGrpSpPr>
          <p:grpSpPr>
            <a:xfrm>
              <a:off x="9499787" y="7641631"/>
              <a:ext cx="4702434" cy="3004925"/>
              <a:chOff x="7715143" y="10034753"/>
              <a:chExt cx="4702435" cy="3004926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A5DABD6E-0345-3B80-27AE-0943E7C3139B}"/>
                  </a:ext>
                </a:extLst>
              </p:cNvPr>
              <p:cNvGrpSpPr/>
              <p:nvPr/>
            </p:nvGrpSpPr>
            <p:grpSpPr>
              <a:xfrm>
                <a:off x="7715143" y="10034753"/>
                <a:ext cx="4702435" cy="3004926"/>
                <a:chOff x="9031743" y="10795668"/>
                <a:chExt cx="4702435" cy="3004926"/>
              </a:xfrm>
            </p:grpSpPr>
            <p:grpSp>
              <p:nvGrpSpPr>
                <p:cNvPr id="27" name="Group 26">
                  <a:extLst>
                    <a:ext uri="{FF2B5EF4-FFF2-40B4-BE49-F238E27FC236}">
                      <a16:creationId xmlns:a16="http://schemas.microsoft.com/office/drawing/2014/main" id="{D8774FEE-F16C-462E-3F23-5E2695665D0F}"/>
                    </a:ext>
                  </a:extLst>
                </p:cNvPr>
                <p:cNvGrpSpPr/>
                <p:nvPr/>
              </p:nvGrpSpPr>
              <p:grpSpPr>
                <a:xfrm>
                  <a:off x="9031743" y="10795668"/>
                  <a:ext cx="886403" cy="2340711"/>
                  <a:chOff x="8390491" y="10423049"/>
                  <a:chExt cx="886403" cy="1723201"/>
                </a:xfrm>
              </p:grpSpPr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D97932B0-B896-BB6A-F81F-FCB71F4269C2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7930251" y="10883289"/>
                    <a:ext cx="1263825" cy="34334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ody weight (g)</a:t>
                    </a:r>
                  </a:p>
                </p:txBody>
              </p:sp>
              <p:sp>
                <p:nvSpPr>
                  <p:cNvPr id="40" name="TextBox 39">
                    <a:extLst>
                      <a:ext uri="{FF2B5EF4-FFF2-40B4-BE49-F238E27FC236}">
                        <a16:creationId xmlns:a16="http://schemas.microsoft.com/office/drawing/2014/main" id="{C463A85B-1D77-1756-813D-4D65DD6B6FC1}"/>
                      </a:ext>
                    </a:extLst>
                  </p:cNvPr>
                  <p:cNvSpPr txBox="1"/>
                  <p:nvPr/>
                </p:nvSpPr>
                <p:spPr>
                  <a:xfrm>
                    <a:off x="8872885" y="10845291"/>
                    <a:ext cx="384160" cy="2295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2</a:t>
                    </a:r>
                  </a:p>
                </p:txBody>
              </p:sp>
              <p:sp>
                <p:nvSpPr>
                  <p:cNvPr id="41" name="TextBox 40">
                    <a:extLst>
                      <a:ext uri="{FF2B5EF4-FFF2-40B4-BE49-F238E27FC236}">
                        <a16:creationId xmlns:a16="http://schemas.microsoft.com/office/drawing/2014/main" id="{B708B333-C9BE-8F2D-9116-57A6C5360798}"/>
                      </a:ext>
                    </a:extLst>
                  </p:cNvPr>
                  <p:cNvSpPr txBox="1"/>
                  <p:nvPr/>
                </p:nvSpPr>
                <p:spPr>
                  <a:xfrm>
                    <a:off x="8892734" y="11239797"/>
                    <a:ext cx="384160" cy="2295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</a:p>
                </p:txBody>
              </p:sp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975A6978-656F-477D-B32E-BBE243533CDD}"/>
                      </a:ext>
                    </a:extLst>
                  </p:cNvPr>
                  <p:cNvSpPr txBox="1"/>
                  <p:nvPr/>
                </p:nvSpPr>
                <p:spPr>
                  <a:xfrm>
                    <a:off x="8876368" y="11603543"/>
                    <a:ext cx="384160" cy="2295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</a:t>
                    </a:r>
                  </a:p>
                </p:txBody>
              </p:sp>
              <p:sp>
                <p:nvSpPr>
                  <p:cNvPr id="43" name="TextBox 42">
                    <a:extLst>
                      <a:ext uri="{FF2B5EF4-FFF2-40B4-BE49-F238E27FC236}">
                        <a16:creationId xmlns:a16="http://schemas.microsoft.com/office/drawing/2014/main" id="{7DB4745F-8616-605A-2510-9B4207B13B6B}"/>
                      </a:ext>
                    </a:extLst>
                  </p:cNvPr>
                  <p:cNvSpPr txBox="1"/>
                  <p:nvPr/>
                </p:nvSpPr>
                <p:spPr>
                  <a:xfrm>
                    <a:off x="8876444" y="10649877"/>
                    <a:ext cx="121223" cy="2295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endParaRPr lang="en-US" sz="2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" name="TextBox 43">
                    <a:extLst>
                      <a:ext uri="{FF2B5EF4-FFF2-40B4-BE49-F238E27FC236}">
                        <a16:creationId xmlns:a16="http://schemas.microsoft.com/office/drawing/2014/main" id="{099779EC-0936-6674-A658-3F8755B52BEF}"/>
                      </a:ext>
                    </a:extLst>
                  </p:cNvPr>
                  <p:cNvSpPr txBox="1"/>
                  <p:nvPr/>
                </p:nvSpPr>
                <p:spPr>
                  <a:xfrm>
                    <a:off x="8876368" y="11727647"/>
                    <a:ext cx="384160" cy="2295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</a:t>
                    </a:r>
                  </a:p>
                </p:txBody>
              </p:sp>
              <p:sp>
                <p:nvSpPr>
                  <p:cNvPr id="45" name="TextBox 44">
                    <a:extLst>
                      <a:ext uri="{FF2B5EF4-FFF2-40B4-BE49-F238E27FC236}">
                        <a16:creationId xmlns:a16="http://schemas.microsoft.com/office/drawing/2014/main" id="{E8D02565-3041-E54E-3398-9AA450E0793B}"/>
                      </a:ext>
                    </a:extLst>
                  </p:cNvPr>
                  <p:cNvSpPr txBox="1"/>
                  <p:nvPr/>
                </p:nvSpPr>
                <p:spPr>
                  <a:xfrm>
                    <a:off x="8867654" y="10469534"/>
                    <a:ext cx="384160" cy="2295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4</a:t>
                    </a:r>
                  </a:p>
                </p:txBody>
              </p: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449763AE-5B52-F260-D4D8-206F19BBBBDE}"/>
                      </a:ext>
                    </a:extLst>
                  </p:cNvPr>
                  <p:cNvSpPr txBox="1"/>
                  <p:nvPr/>
                </p:nvSpPr>
                <p:spPr>
                  <a:xfrm>
                    <a:off x="8966813" y="11916719"/>
                    <a:ext cx="252670" cy="2295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</a:t>
                    </a:r>
                  </a:p>
                </p:txBody>
              </p:sp>
            </p:grpSp>
            <p:grpSp>
              <p:nvGrpSpPr>
                <p:cNvPr id="28" name="Group 27">
                  <a:extLst>
                    <a:ext uri="{FF2B5EF4-FFF2-40B4-BE49-F238E27FC236}">
                      <a16:creationId xmlns:a16="http://schemas.microsoft.com/office/drawing/2014/main" id="{9F8125DD-35F6-4044-B9AD-958777B6FD8D}"/>
                    </a:ext>
                  </a:extLst>
                </p:cNvPr>
                <p:cNvGrpSpPr/>
                <p:nvPr/>
              </p:nvGrpSpPr>
              <p:grpSpPr>
                <a:xfrm>
                  <a:off x="9794654" y="13231448"/>
                  <a:ext cx="3939524" cy="569146"/>
                  <a:chOff x="11825035" y="5980789"/>
                  <a:chExt cx="3380597" cy="569146"/>
                </a:xfrm>
              </p:grpSpPr>
              <p:sp>
                <p:nvSpPr>
                  <p:cNvPr id="29" name="TextBox 28">
                    <a:extLst>
                      <a:ext uri="{FF2B5EF4-FFF2-40B4-BE49-F238E27FC236}">
                        <a16:creationId xmlns:a16="http://schemas.microsoft.com/office/drawing/2014/main" id="{777794E9-B486-41B0-09DC-A43E48CA1DF9}"/>
                      </a:ext>
                    </a:extLst>
                  </p:cNvPr>
                  <p:cNvSpPr txBox="1"/>
                  <p:nvPr/>
                </p:nvSpPr>
                <p:spPr>
                  <a:xfrm>
                    <a:off x="12244684" y="6238153"/>
                    <a:ext cx="2960948" cy="31178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ays post tumor implantation</a:t>
                    </a:r>
                  </a:p>
                </p:txBody>
              </p:sp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B2B26E77-15E2-2AAA-2FFC-242458C02C8B}"/>
                      </a:ext>
                    </a:extLst>
                  </p:cNvPr>
                  <p:cNvSpPr txBox="1"/>
                  <p:nvPr/>
                </p:nvSpPr>
                <p:spPr>
                  <a:xfrm>
                    <a:off x="12157740" y="5980789"/>
                    <a:ext cx="194655" cy="3117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31" name="TextBox 30">
                    <a:extLst>
                      <a:ext uri="{FF2B5EF4-FFF2-40B4-BE49-F238E27FC236}">
                        <a16:creationId xmlns:a16="http://schemas.microsoft.com/office/drawing/2014/main" id="{E4562B0C-7202-7DC6-7B01-35A652D040E7}"/>
                      </a:ext>
                    </a:extLst>
                  </p:cNvPr>
                  <p:cNvSpPr txBox="1"/>
                  <p:nvPr/>
                </p:nvSpPr>
                <p:spPr>
                  <a:xfrm>
                    <a:off x="12496855" y="5980789"/>
                    <a:ext cx="194655" cy="3117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  <p:sp>
                <p:nvSpPr>
                  <p:cNvPr id="32" name="TextBox 31">
                    <a:extLst>
                      <a:ext uri="{FF2B5EF4-FFF2-40B4-BE49-F238E27FC236}">
                        <a16:creationId xmlns:a16="http://schemas.microsoft.com/office/drawing/2014/main" id="{9DEF9AA0-A429-9E87-A921-E6A4BF5B0027}"/>
                      </a:ext>
                    </a:extLst>
                  </p:cNvPr>
                  <p:cNvSpPr txBox="1"/>
                  <p:nvPr/>
                </p:nvSpPr>
                <p:spPr>
                  <a:xfrm>
                    <a:off x="12856802" y="5980789"/>
                    <a:ext cx="194655" cy="3117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</a:t>
                    </a:r>
                  </a:p>
                </p:txBody>
              </p:sp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1089851F-2789-3CE0-37A2-A4F3100DC801}"/>
                      </a:ext>
                    </a:extLst>
                  </p:cNvPr>
                  <p:cNvSpPr txBox="1"/>
                  <p:nvPr/>
                </p:nvSpPr>
                <p:spPr>
                  <a:xfrm>
                    <a:off x="13207018" y="5980789"/>
                    <a:ext cx="194655" cy="3117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34" name="TextBox 33">
                    <a:extLst>
                      <a:ext uri="{FF2B5EF4-FFF2-40B4-BE49-F238E27FC236}">
                        <a16:creationId xmlns:a16="http://schemas.microsoft.com/office/drawing/2014/main" id="{4B4E414D-EE8F-EC8A-6A90-272F8DD4C30C}"/>
                      </a:ext>
                    </a:extLst>
                  </p:cNvPr>
                  <p:cNvSpPr txBox="1"/>
                  <p:nvPr/>
                </p:nvSpPr>
                <p:spPr>
                  <a:xfrm>
                    <a:off x="13505956" y="5980789"/>
                    <a:ext cx="369580" cy="3117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35" name="TextBox 34">
                    <a:extLst>
                      <a:ext uri="{FF2B5EF4-FFF2-40B4-BE49-F238E27FC236}">
                        <a16:creationId xmlns:a16="http://schemas.microsoft.com/office/drawing/2014/main" id="{3DE39A87-E1EC-454F-2214-BD133EA9A895}"/>
                      </a:ext>
                    </a:extLst>
                  </p:cNvPr>
                  <p:cNvSpPr txBox="1"/>
                  <p:nvPr/>
                </p:nvSpPr>
                <p:spPr>
                  <a:xfrm>
                    <a:off x="14194096" y="5980789"/>
                    <a:ext cx="464842" cy="3117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4</a:t>
                    </a:r>
                  </a:p>
                </p:txBody>
              </p:sp>
              <p:sp>
                <p:nvSpPr>
                  <p:cNvPr id="36" name="TextBox 35">
                    <a:extLst>
                      <a:ext uri="{FF2B5EF4-FFF2-40B4-BE49-F238E27FC236}">
                        <a16:creationId xmlns:a16="http://schemas.microsoft.com/office/drawing/2014/main" id="{B48E6BEE-223B-0474-A8E8-B98E333E8122}"/>
                      </a:ext>
                    </a:extLst>
                  </p:cNvPr>
                  <p:cNvSpPr txBox="1"/>
                  <p:nvPr/>
                </p:nvSpPr>
                <p:spPr>
                  <a:xfrm>
                    <a:off x="14551988" y="5980789"/>
                    <a:ext cx="368331" cy="3117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6</a:t>
                    </a:r>
                  </a:p>
                </p:txBody>
              </p:sp>
              <p:sp>
                <p:nvSpPr>
                  <p:cNvPr id="37" name="TextBox 36">
                    <a:extLst>
                      <a:ext uri="{FF2B5EF4-FFF2-40B4-BE49-F238E27FC236}">
                        <a16:creationId xmlns:a16="http://schemas.microsoft.com/office/drawing/2014/main" id="{F008E4EE-791F-B001-9113-FC0C74CF8332}"/>
                      </a:ext>
                    </a:extLst>
                  </p:cNvPr>
                  <p:cNvSpPr txBox="1"/>
                  <p:nvPr/>
                </p:nvSpPr>
                <p:spPr>
                  <a:xfrm>
                    <a:off x="13857956" y="5980789"/>
                    <a:ext cx="349046" cy="3117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</a:t>
                    </a:r>
                  </a:p>
                </p:txBody>
              </p:sp>
              <p:sp>
                <p:nvSpPr>
                  <p:cNvPr id="38" name="TextBox 37">
                    <a:extLst>
                      <a:ext uri="{FF2B5EF4-FFF2-40B4-BE49-F238E27FC236}">
                        <a16:creationId xmlns:a16="http://schemas.microsoft.com/office/drawing/2014/main" id="{1E251A4A-6A41-D5D0-5518-6D8B4B0810B6}"/>
                      </a:ext>
                    </a:extLst>
                  </p:cNvPr>
                  <p:cNvSpPr txBox="1"/>
                  <p:nvPr/>
                </p:nvSpPr>
                <p:spPr>
                  <a:xfrm>
                    <a:off x="11825035" y="5980789"/>
                    <a:ext cx="194655" cy="3117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</p:grpSp>
          </p:grpSp>
          <p:pic>
            <p:nvPicPr>
              <p:cNvPr id="26" name="Picture 25" descr="Chart, box and whisker chart&#10;&#10;Description automatically generated">
                <a:extLst>
                  <a:ext uri="{FF2B5EF4-FFF2-40B4-BE49-F238E27FC236}">
                    <a16:creationId xmlns:a16="http://schemas.microsoft.com/office/drawing/2014/main" id="{C7BEA8CD-3B2E-C1FE-6F92-D454424AA3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548440" y="10201661"/>
                <a:ext cx="3361962" cy="2288903"/>
              </a:xfrm>
              <a:prstGeom prst="rect">
                <a:avLst/>
              </a:prstGeom>
            </p:spPr>
          </p:pic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4FD079D-F5E4-5939-E82C-2682AACFA1C7}"/>
                </a:ext>
              </a:extLst>
            </p:cNvPr>
            <p:cNvSpPr txBox="1"/>
            <p:nvPr/>
          </p:nvSpPr>
          <p:spPr>
            <a:xfrm>
              <a:off x="12229377" y="7405497"/>
              <a:ext cx="757589" cy="3117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(n=5) </a:t>
              </a:r>
            </a:p>
          </p:txBody>
        </p:sp>
        <p:pic>
          <p:nvPicPr>
            <p:cNvPr id="24" name="Picture 23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A9D4791E-2185-6458-EBA1-91215E47493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446289" y="6974218"/>
              <a:ext cx="1649126" cy="811876"/>
            </a:xfrm>
            <a:prstGeom prst="rect">
              <a:avLst/>
            </a:prstGeom>
          </p:spPr>
        </p:pic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5FC16EC5-ED3A-2702-AA3D-DE7128271171}"/>
              </a:ext>
            </a:extLst>
          </p:cNvPr>
          <p:cNvSpPr txBox="1"/>
          <p:nvPr/>
        </p:nvSpPr>
        <p:spPr>
          <a:xfrm>
            <a:off x="1134820" y="16213300"/>
            <a:ext cx="221935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Figure S2 : Body weights of LLC-GFP subcutaneous mouse model following injection of PBS or DOPG LVs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3AC8F5C-EE7D-8238-E398-773EBF29335D}"/>
              </a:ext>
            </a:extLst>
          </p:cNvPr>
          <p:cNvSpPr txBox="1"/>
          <p:nvPr/>
        </p:nvSpPr>
        <p:spPr>
          <a:xfrm>
            <a:off x="10764331" y="7636935"/>
            <a:ext cx="79476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LVs</a:t>
            </a:r>
          </a:p>
        </p:txBody>
      </p:sp>
    </p:spTree>
    <p:extLst>
      <p:ext uri="{BB962C8B-B14F-4D97-AF65-F5344CB8AC3E}">
        <p14:creationId xmlns:p14="http://schemas.microsoft.com/office/powerpoint/2010/main" val="42261837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BF73A2F-83D7-E747-C3B3-41CFB48438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56601" y="3821985"/>
            <a:ext cx="7674316" cy="5351961"/>
          </a:xfrm>
          <a:prstGeom prst="rect">
            <a:avLst/>
          </a:prstGeom>
          <a:noFill/>
          <a:ln>
            <a:noFill/>
          </a:ln>
        </p:spPr>
      </p:pic>
      <p:sp>
        <p:nvSpPr>
          <p:cNvPr id="238" name="Rectangle 237">
            <a:extLst>
              <a:ext uri="{FF2B5EF4-FFF2-40B4-BE49-F238E27FC236}">
                <a16:creationId xmlns:a16="http://schemas.microsoft.com/office/drawing/2014/main" id="{F3E60488-128D-4BF0-B614-5A54FF9BC16D}"/>
              </a:ext>
            </a:extLst>
          </p:cNvPr>
          <p:cNvSpPr/>
          <p:nvPr/>
        </p:nvSpPr>
        <p:spPr>
          <a:xfrm>
            <a:off x="16130465" y="2576602"/>
            <a:ext cx="51809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CB68D036-513F-4D8A-8508-F3024C4DE704}"/>
              </a:ext>
            </a:extLst>
          </p:cNvPr>
          <p:cNvSpPr/>
          <p:nvPr/>
        </p:nvSpPr>
        <p:spPr>
          <a:xfrm>
            <a:off x="1178749" y="2576602"/>
            <a:ext cx="51809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0" name="Rectangle 229">
            <a:extLst>
              <a:ext uri="{FF2B5EF4-FFF2-40B4-BE49-F238E27FC236}">
                <a16:creationId xmlns:a16="http://schemas.microsoft.com/office/drawing/2014/main" id="{92374B65-8545-4F24-9EFB-52F162DD0265}"/>
              </a:ext>
            </a:extLst>
          </p:cNvPr>
          <p:cNvSpPr/>
          <p:nvPr/>
        </p:nvSpPr>
        <p:spPr>
          <a:xfrm>
            <a:off x="8654607" y="2576602"/>
            <a:ext cx="51809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1" name="Rectangle 230">
            <a:extLst>
              <a:ext uri="{FF2B5EF4-FFF2-40B4-BE49-F238E27FC236}">
                <a16:creationId xmlns:a16="http://schemas.microsoft.com/office/drawing/2014/main" id="{2114D12A-DA04-48C4-94AE-BF7E3E0D9AC9}"/>
              </a:ext>
            </a:extLst>
          </p:cNvPr>
          <p:cNvSpPr/>
          <p:nvPr/>
        </p:nvSpPr>
        <p:spPr>
          <a:xfrm>
            <a:off x="1230045" y="9549204"/>
            <a:ext cx="51809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896F95C-AA02-190C-9D6D-6DDA7613D0A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5329" y="3821985"/>
            <a:ext cx="7660049" cy="5351961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80D7E00-6B62-755B-2087-72D3DE711E3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63093" y="3821984"/>
            <a:ext cx="7660051" cy="5351962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6E6EFFD-F2E7-161E-8D27-BBA2CDB4168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095" y="10331072"/>
            <a:ext cx="7655282" cy="5351961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9F83532-1768-D348-42D1-E8D1B61C824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65300" y="10131155"/>
            <a:ext cx="7655282" cy="5351962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C7E18F7-7D50-4310-B712-F2DC2755E4C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20582" y="10195535"/>
            <a:ext cx="7653818" cy="5351963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532FCBF3-9CCD-4405-C36C-EAA37B859B21}"/>
              </a:ext>
            </a:extLst>
          </p:cNvPr>
          <p:cNvSpPr/>
          <p:nvPr/>
        </p:nvSpPr>
        <p:spPr>
          <a:xfrm>
            <a:off x="8913652" y="9549204"/>
            <a:ext cx="4924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1E73E3B3-EFC4-8563-FF69-FAB7E5DC7525}"/>
              </a:ext>
            </a:extLst>
          </p:cNvPr>
          <p:cNvSpPr/>
          <p:nvPr/>
        </p:nvSpPr>
        <p:spPr>
          <a:xfrm>
            <a:off x="16233323" y="9594869"/>
            <a:ext cx="46679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13D63C6-30EC-47A7-C88A-7E5C8ECFD044}"/>
              </a:ext>
            </a:extLst>
          </p:cNvPr>
          <p:cNvSpPr txBox="1"/>
          <p:nvPr/>
        </p:nvSpPr>
        <p:spPr>
          <a:xfrm>
            <a:off x="933727" y="18298446"/>
            <a:ext cx="21545273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Figure S3: The signal of </a:t>
            </a:r>
            <a:r>
              <a:rPr lang="en-US" sz="3600" b="1" dirty="0" err="1">
                <a:latin typeface="Arial" panose="020B0604020202020204" pitchFamily="34" charset="0"/>
                <a:cs typeface="Arial" panose="020B0604020202020204" pitchFamily="34" charset="0"/>
              </a:rPr>
              <a:t>SapC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-DOPG-CVM measured at mice organs. 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The signal of </a:t>
            </a:r>
            <a:r>
              <a:rPr lang="en-US" sz="3600" dirty="0" err="1">
                <a:latin typeface="Arial" panose="020B0604020202020204" pitchFamily="34" charset="0"/>
                <a:cs typeface="Arial" panose="020B0604020202020204" pitchFamily="34" charset="0"/>
              </a:rPr>
              <a:t>SapC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-DOPG-CVM from lung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, brain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, bladder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, ovary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, kidney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, and heart (</a:t>
            </a:r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) of mice at indicated time points between 0-48 hrs. The signal was normalized based on the area. </a:t>
            </a:r>
          </a:p>
          <a:p>
            <a:pPr algn="just"/>
            <a:endParaRPr 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6804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26</TotalTime>
  <Words>175</Words>
  <Application>Microsoft Office PowerPoint</Application>
  <PresentationFormat>Custom</PresentationFormat>
  <Paragraphs>28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2013 - 2022 Theme</vt:lpstr>
      <vt:lpstr>Prism 6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ynak, Ahmet (kaynakat)</dc:creator>
  <cp:lastModifiedBy>Kaynak, Ahmet (kaynakat)</cp:lastModifiedBy>
  <cp:revision>45</cp:revision>
  <dcterms:created xsi:type="dcterms:W3CDTF">2021-11-16T17:09:50Z</dcterms:created>
  <dcterms:modified xsi:type="dcterms:W3CDTF">2025-03-10T14:13:45Z</dcterms:modified>
</cp:coreProperties>
</file>